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75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7" d="100"/>
          <a:sy n="57" d="100"/>
        </p:scale>
        <p:origin x="2587" y="6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668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486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825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726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835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133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426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563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10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33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970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593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49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-6338" y="-24969"/>
            <a:ext cx="6849762" cy="8741596"/>
            <a:chOff x="-6338" y="-24969"/>
            <a:chExt cx="6849762" cy="8741596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00" t="33165" r="27222"/>
            <a:stretch/>
          </p:blipFill>
          <p:spPr>
            <a:xfrm>
              <a:off x="4579620" y="-24969"/>
              <a:ext cx="2263804" cy="4982831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00" r="27222" b="66760"/>
            <a:stretch/>
          </p:blipFill>
          <p:spPr>
            <a:xfrm>
              <a:off x="2262783" y="6204639"/>
              <a:ext cx="2263804" cy="2478182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778" t="16667" r="52111"/>
            <a:stretch/>
          </p:blipFill>
          <p:spPr>
            <a:xfrm>
              <a:off x="2251411" y="1"/>
              <a:ext cx="2296899" cy="6212827"/>
            </a:xfrm>
            <a:prstGeom prst="rect">
              <a:avLst/>
            </a:prstGeom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222" r="2236" b="66592"/>
            <a:stretch/>
          </p:blipFill>
          <p:spPr>
            <a:xfrm>
              <a:off x="4579620" y="4953023"/>
              <a:ext cx="2240280" cy="2490707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7444"/>
            <a:stretch/>
          </p:blipFill>
          <p:spPr>
            <a:xfrm>
              <a:off x="16189" y="0"/>
              <a:ext cx="2241739" cy="7455422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778" r="52111" b="82889"/>
            <a:stretch/>
          </p:blipFill>
          <p:spPr>
            <a:xfrm>
              <a:off x="-6338" y="7440930"/>
              <a:ext cx="2296899" cy="1275697"/>
            </a:xfrm>
            <a:prstGeom prst="rect">
              <a:avLst/>
            </a:prstGeom>
          </p:spPr>
        </p:pic>
      </p:grpSp>
      <p:sp>
        <p:nvSpPr>
          <p:cNvPr id="9" name="TextBox 8"/>
          <p:cNvSpPr txBox="1"/>
          <p:nvPr/>
        </p:nvSpPr>
        <p:spPr>
          <a:xfrm>
            <a:off x="16189" y="8816445"/>
            <a:ext cx="68037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SNP-index plots for 20 pseudomolecules of rust resistant bulk with the resistant parent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 lines indicate the sliding window average of 2 Mb interval with 50 kb increment for SNP-index.</a:t>
            </a:r>
          </a:p>
        </p:txBody>
      </p:sp>
    </p:spTree>
    <p:extLst>
      <p:ext uri="{BB962C8B-B14F-4D97-AF65-F5344CB8AC3E}">
        <p14:creationId xmlns:p14="http://schemas.microsoft.com/office/powerpoint/2010/main" val="34460236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0</TotalTime>
  <Words>35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Vikas (ICRISAT-IN)</dc:creator>
  <cp:lastModifiedBy>Pandey</cp:lastModifiedBy>
  <cp:revision>89</cp:revision>
  <dcterms:created xsi:type="dcterms:W3CDTF">2015-04-20T11:32:42Z</dcterms:created>
  <dcterms:modified xsi:type="dcterms:W3CDTF">2016-09-26T10:46:24Z</dcterms:modified>
</cp:coreProperties>
</file>